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7AB17D-BCB2-44FE-ABBB-A71590AE17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60214B-BA0B-452A-BD6D-EFAEF147F57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72226-926B-40F5-A357-5315B2080B6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5887E-7BBF-43C7-8A10-F3FCCBAA489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9EE668-091F-40BD-A257-14A67BC3FFA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F5DAB5-761A-48ED-93D3-C06A920EC7C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46B840-EFB9-4DD4-8C25-5AD3C830FD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7CD66C-9808-41D5-86ED-84037ED2FC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95E837-2707-4D32-A406-A84D1E4E62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7E0F78-DACB-40EB-A596-1940B671A92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13DC1-22D5-4CA0-A614-FDC1D64FB0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4A403B-9B5A-4766-B7E9-2D875FB297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013D186-1298-4364-B798-C551AA844F5F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D1AB609-B0AF-4D29-9114-33E6F3D6B538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线连接符 23"/>
          <p:cNvSpPr/>
          <p:nvPr/>
        </p:nvSpPr>
        <p:spPr>
          <a:xfrm>
            <a:off x="1379520" y="597204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4"/>
          <p:cNvSpPr/>
          <p:nvPr/>
        </p:nvSpPr>
        <p:spPr>
          <a:xfrm>
            <a:off x="1488960" y="223200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文本框 63"/>
          <p:cNvSpPr/>
          <p:nvPr/>
        </p:nvSpPr>
        <p:spPr>
          <a:xfrm>
            <a:off x="3963960" y="2260440"/>
            <a:ext cx="1239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Volume (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L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14"/>
          <p:cNvSpPr/>
          <p:nvPr/>
        </p:nvSpPr>
        <p:spPr>
          <a:xfrm>
            <a:off x="1379520" y="2748600"/>
            <a:ext cx="287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0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×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 KOD Buffer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矩形 15"/>
          <p:cNvSpPr/>
          <p:nvPr/>
        </p:nvSpPr>
        <p:spPr>
          <a:xfrm>
            <a:off x="5554800" y="2273400"/>
            <a:ext cx="162216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Final concent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65"/>
          <p:cNvSpPr/>
          <p:nvPr/>
        </p:nvSpPr>
        <p:spPr>
          <a:xfrm>
            <a:off x="1382760" y="1765440"/>
            <a:ext cx="74851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5</a:t>
            </a:r>
            <a:r>
              <a:rPr b="1" lang="en-US" sz="1300" spc="-1" strike="noStrike">
                <a:solidFill>
                  <a:srgbClr val="000000"/>
                </a:solidFill>
                <a:latin typeface="Times New Roman"/>
              </a:rPr>
              <a:t>  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PCR Reaction Mix (Wild-type Fragment Amplification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6"/>
          <p:cNvSpPr/>
          <p:nvPr/>
        </p:nvSpPr>
        <p:spPr>
          <a:xfrm>
            <a:off x="1565280" y="2270160"/>
            <a:ext cx="10206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Component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7"/>
          <p:cNvSpPr/>
          <p:nvPr/>
        </p:nvSpPr>
        <p:spPr>
          <a:xfrm>
            <a:off x="1379520" y="3155040"/>
            <a:ext cx="287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dNTP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8"/>
          <p:cNvSpPr/>
          <p:nvPr/>
        </p:nvSpPr>
        <p:spPr>
          <a:xfrm>
            <a:off x="1379520" y="3561480"/>
            <a:ext cx="287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MgSO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₄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9"/>
          <p:cNvSpPr/>
          <p:nvPr/>
        </p:nvSpPr>
        <p:spPr>
          <a:xfrm>
            <a:off x="1379520" y="3967920"/>
            <a:ext cx="287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KOD-Plus-Neo polymerase(1 U/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5"/>
          <p:cNvSpPr/>
          <p:nvPr/>
        </p:nvSpPr>
        <p:spPr>
          <a:xfrm>
            <a:off x="5504040" y="2584440"/>
            <a:ext cx="180000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X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30"/>
          <p:cNvSpPr/>
          <p:nvPr/>
        </p:nvSpPr>
        <p:spPr>
          <a:xfrm>
            <a:off x="5504040" y="3798720"/>
            <a:ext cx="180000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 U/50 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31"/>
          <p:cNvSpPr/>
          <p:nvPr/>
        </p:nvSpPr>
        <p:spPr>
          <a:xfrm>
            <a:off x="5504040" y="4240080"/>
            <a:ext cx="180000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0.3 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67"/>
          <p:cNvSpPr/>
          <p:nvPr/>
        </p:nvSpPr>
        <p:spPr>
          <a:xfrm>
            <a:off x="4032360" y="2706840"/>
            <a:ext cx="1079280" cy="46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本框 71"/>
          <p:cNvSpPr/>
          <p:nvPr/>
        </p:nvSpPr>
        <p:spPr>
          <a:xfrm>
            <a:off x="4032360" y="3129120"/>
            <a:ext cx="1079280" cy="46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72"/>
          <p:cNvSpPr/>
          <p:nvPr/>
        </p:nvSpPr>
        <p:spPr>
          <a:xfrm>
            <a:off x="4032360" y="3551400"/>
            <a:ext cx="1079280" cy="46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3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73"/>
          <p:cNvSpPr/>
          <p:nvPr/>
        </p:nvSpPr>
        <p:spPr>
          <a:xfrm>
            <a:off x="4032360" y="3971880"/>
            <a:ext cx="107928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直线连接符 1"/>
          <p:cNvSpPr/>
          <p:nvPr/>
        </p:nvSpPr>
        <p:spPr>
          <a:xfrm>
            <a:off x="1488960" y="2639880"/>
            <a:ext cx="5688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58"/>
          <p:cNvSpPr/>
          <p:nvPr/>
        </p:nvSpPr>
        <p:spPr>
          <a:xfrm>
            <a:off x="1379520" y="4372920"/>
            <a:ext cx="287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forward primers(10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59"/>
          <p:cNvSpPr/>
          <p:nvPr/>
        </p:nvSpPr>
        <p:spPr>
          <a:xfrm>
            <a:off x="4032360" y="4394160"/>
            <a:ext cx="107928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.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1"/>
          <p:cNvSpPr/>
          <p:nvPr/>
        </p:nvSpPr>
        <p:spPr>
          <a:xfrm>
            <a:off x="1379520" y="5185440"/>
            <a:ext cx="287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Genomic DNA (~100 ng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2"/>
          <p:cNvSpPr/>
          <p:nvPr/>
        </p:nvSpPr>
        <p:spPr>
          <a:xfrm>
            <a:off x="1379520" y="5591880"/>
            <a:ext cx="287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ddH₂O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本框 3"/>
          <p:cNvSpPr/>
          <p:nvPr/>
        </p:nvSpPr>
        <p:spPr>
          <a:xfrm>
            <a:off x="4043520" y="5560920"/>
            <a:ext cx="1081080" cy="46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31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本框 11"/>
          <p:cNvSpPr/>
          <p:nvPr/>
        </p:nvSpPr>
        <p:spPr>
          <a:xfrm>
            <a:off x="5504040" y="3389400"/>
            <a:ext cx="180000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 baseline="30000">
                <a:solidFill>
                  <a:srgbClr val="000000"/>
                </a:solidFill>
                <a:latin typeface="Times New Roman"/>
              </a:rPr>
              <a:t>_______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文本框 12"/>
          <p:cNvSpPr/>
          <p:nvPr/>
        </p:nvSpPr>
        <p:spPr>
          <a:xfrm>
            <a:off x="5504040" y="4653000"/>
            <a:ext cx="180000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0.3 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本框 16"/>
          <p:cNvSpPr/>
          <p:nvPr/>
        </p:nvSpPr>
        <p:spPr>
          <a:xfrm>
            <a:off x="1379520" y="4779000"/>
            <a:ext cx="2879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Reverse primers(10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M)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本框 17"/>
          <p:cNvSpPr/>
          <p:nvPr/>
        </p:nvSpPr>
        <p:spPr>
          <a:xfrm>
            <a:off x="4032360" y="4816440"/>
            <a:ext cx="107928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1.5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本框 19"/>
          <p:cNvSpPr/>
          <p:nvPr/>
        </p:nvSpPr>
        <p:spPr>
          <a:xfrm>
            <a:off x="5504040" y="5067360"/>
            <a:ext cx="180000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~100 ng/50</a:t>
            </a: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 μ</a:t>
            </a: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L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本框 25"/>
          <p:cNvSpPr/>
          <p:nvPr/>
        </p:nvSpPr>
        <p:spPr>
          <a:xfrm>
            <a:off x="4032360" y="5192640"/>
            <a:ext cx="107928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</a:rPr>
              <a:t>2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本框 28"/>
          <p:cNvSpPr/>
          <p:nvPr/>
        </p:nvSpPr>
        <p:spPr>
          <a:xfrm>
            <a:off x="5506920" y="5478480"/>
            <a:ext cx="179892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 baseline="30000">
                <a:solidFill>
                  <a:srgbClr val="000000"/>
                </a:solidFill>
                <a:latin typeface="Times New Roman"/>
              </a:rPr>
              <a:t>_______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本框 29"/>
          <p:cNvSpPr/>
          <p:nvPr/>
        </p:nvSpPr>
        <p:spPr>
          <a:xfrm>
            <a:off x="5504040" y="2971800"/>
            <a:ext cx="1800000" cy="46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 baseline="30000">
                <a:solidFill>
                  <a:srgbClr val="000000"/>
                </a:solidFill>
                <a:latin typeface="Times New Roman"/>
              </a:rPr>
              <a:t>_______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5:05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